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3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idx="11"/>
          </p:nvPr>
        </p:nvSpPr>
        <p:spPr/>
        <p:txBody>
          <a:bodyPr/>
          <a:lstStyle/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9738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18" Type="http://schemas.openxmlformats.org/officeDocument/2006/relationships/image" Target="../media/image16.jpg"/><Relationship Id="rId26" Type="http://schemas.openxmlformats.org/officeDocument/2006/relationships/image" Target="../media/image24.jpg"/><Relationship Id="rId3" Type="http://schemas.openxmlformats.org/officeDocument/2006/relationships/image" Target="../media/image1.jpg"/><Relationship Id="rId21" Type="http://schemas.openxmlformats.org/officeDocument/2006/relationships/image" Target="../media/image19.jpg"/><Relationship Id="rId34" Type="http://schemas.openxmlformats.org/officeDocument/2006/relationships/image" Target="../media/image32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17" Type="http://schemas.openxmlformats.org/officeDocument/2006/relationships/image" Target="../media/image15.jpg"/><Relationship Id="rId25" Type="http://schemas.openxmlformats.org/officeDocument/2006/relationships/image" Target="../media/image23.jpg"/><Relationship Id="rId33" Type="http://schemas.openxmlformats.org/officeDocument/2006/relationships/image" Target="../media/image31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20" Type="http://schemas.openxmlformats.org/officeDocument/2006/relationships/image" Target="../media/image18.jpg"/><Relationship Id="rId29" Type="http://schemas.openxmlformats.org/officeDocument/2006/relationships/image" Target="../media/image2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24" Type="http://schemas.openxmlformats.org/officeDocument/2006/relationships/image" Target="../media/image22.jpg"/><Relationship Id="rId32" Type="http://schemas.openxmlformats.org/officeDocument/2006/relationships/image" Target="../media/image30.jpg"/><Relationship Id="rId5" Type="http://schemas.openxmlformats.org/officeDocument/2006/relationships/image" Target="../media/image3.jpg"/><Relationship Id="rId15" Type="http://schemas.openxmlformats.org/officeDocument/2006/relationships/image" Target="../media/image13.jpg"/><Relationship Id="rId23" Type="http://schemas.openxmlformats.org/officeDocument/2006/relationships/image" Target="../media/image21.jpg"/><Relationship Id="rId28" Type="http://schemas.openxmlformats.org/officeDocument/2006/relationships/image" Target="../media/image26.jpg"/><Relationship Id="rId10" Type="http://schemas.openxmlformats.org/officeDocument/2006/relationships/image" Target="../media/image8.jpg"/><Relationship Id="rId19" Type="http://schemas.openxmlformats.org/officeDocument/2006/relationships/image" Target="../media/image17.jpg"/><Relationship Id="rId31" Type="http://schemas.openxmlformats.org/officeDocument/2006/relationships/image" Target="../media/image29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jpg"/><Relationship Id="rId22" Type="http://schemas.openxmlformats.org/officeDocument/2006/relationships/image" Target="../media/image20.jpg"/><Relationship Id="rId27" Type="http://schemas.openxmlformats.org/officeDocument/2006/relationships/image" Target="../media/image25.jpg"/><Relationship Id="rId30" Type="http://schemas.openxmlformats.org/officeDocument/2006/relationships/image" Target="../media/image28.jpg"/><Relationship Id="rId35" Type="http://schemas.openxmlformats.org/officeDocument/2006/relationships/image" Target="../media/image3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9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94958" y="1924642"/>
            <a:ext cx="1283172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T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T 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グループ化 69"/>
          <p:cNvGrpSpPr/>
          <p:nvPr/>
        </p:nvGrpSpPr>
        <p:grpSpPr>
          <a:xfrm>
            <a:off x="1596212" y="1271640"/>
            <a:ext cx="1519773" cy="805645"/>
            <a:chOff x="1174045" y="646726"/>
            <a:chExt cx="1519773" cy="805645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1570904" y="646726"/>
              <a:ext cx="6992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-2/ad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4" name="直線コネクタ 63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9" name="図 6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63845" r="65223" b="33195"/>
          <a:stretch/>
        </p:blipFill>
        <p:spPr>
          <a:xfrm>
            <a:off x="1558189" y="4805732"/>
            <a:ext cx="1488229" cy="1409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図 8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5" t="58988" r="65290" b="37957"/>
          <a:stretch/>
        </p:blipFill>
        <p:spPr>
          <a:xfrm>
            <a:off x="1530382" y="3931383"/>
            <a:ext cx="1507118" cy="1455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図 9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62920" r="65267" b="33990"/>
          <a:stretch/>
        </p:blipFill>
        <p:spPr>
          <a:xfrm>
            <a:off x="1542446" y="4509639"/>
            <a:ext cx="1486133" cy="1471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図 9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42564" r="65339" b="54063"/>
          <a:stretch/>
        </p:blipFill>
        <p:spPr>
          <a:xfrm>
            <a:off x="1552415" y="2908193"/>
            <a:ext cx="1471703" cy="1606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図 9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6" t="49272" r="65268" b="47243"/>
          <a:stretch/>
        </p:blipFill>
        <p:spPr>
          <a:xfrm>
            <a:off x="1535889" y="3665601"/>
            <a:ext cx="1497150" cy="1659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図 9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5" t="53899" r="65218" b="43043"/>
          <a:stretch/>
        </p:blipFill>
        <p:spPr>
          <a:xfrm>
            <a:off x="1535889" y="4225626"/>
            <a:ext cx="1510531" cy="1456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図 9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59450" r="65339" b="37740"/>
          <a:stretch/>
        </p:blipFill>
        <p:spPr>
          <a:xfrm>
            <a:off x="1541399" y="3425639"/>
            <a:ext cx="1482720" cy="1338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5" name="図 10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" t="48200" r="65274" b="49014"/>
          <a:stretch/>
        </p:blipFill>
        <p:spPr>
          <a:xfrm>
            <a:off x="1540553" y="3190399"/>
            <a:ext cx="1501407" cy="1326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6" name="図 105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8" t="49400" r="65338" b="47997"/>
          <a:stretch/>
        </p:blipFill>
        <p:spPr>
          <a:xfrm>
            <a:off x="1540250" y="2347135"/>
            <a:ext cx="1479407" cy="1239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7" name="図 106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" t="41600" r="65274" b="54603"/>
          <a:stretch/>
        </p:blipFill>
        <p:spPr>
          <a:xfrm>
            <a:off x="1545013" y="2604310"/>
            <a:ext cx="1501407" cy="1808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テキスト ボックス 44"/>
          <p:cNvSpPr txBox="1"/>
          <p:nvPr/>
        </p:nvSpPr>
        <p:spPr>
          <a:xfrm>
            <a:off x="781383" y="900028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8" name="グループ化 47"/>
          <p:cNvGrpSpPr/>
          <p:nvPr/>
        </p:nvGrpSpPr>
        <p:grpSpPr>
          <a:xfrm>
            <a:off x="5424183" y="1266967"/>
            <a:ext cx="1519773" cy="805645"/>
            <a:chOff x="1174045" y="646726"/>
            <a:chExt cx="1519773" cy="805645"/>
          </a:xfrm>
        </p:grpSpPr>
        <p:sp>
          <p:nvSpPr>
            <p:cNvPr id="49" name="テキスト ボックス 48"/>
            <p:cNvSpPr txBox="1"/>
            <p:nvPr/>
          </p:nvSpPr>
          <p:spPr>
            <a:xfrm>
              <a:off x="1732829" y="646726"/>
              <a:ext cx="6046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u-6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直線コネクタ 53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7" name="図 5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0" t="48834" r="65261" b="48050"/>
          <a:stretch/>
        </p:blipFill>
        <p:spPr>
          <a:xfrm>
            <a:off x="5391576" y="3687640"/>
            <a:ext cx="1495417" cy="1483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図 57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7" t="53009" r="65334" b="43727"/>
          <a:stretch/>
        </p:blipFill>
        <p:spPr>
          <a:xfrm>
            <a:off x="5391576" y="4247009"/>
            <a:ext cx="1482036" cy="1554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図 58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3" t="42114" r="65110" b="55362"/>
          <a:stretch/>
        </p:blipFill>
        <p:spPr>
          <a:xfrm>
            <a:off x="5365560" y="2605119"/>
            <a:ext cx="1534815" cy="1456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図 59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4" t="51663" r="64795" b="45102"/>
          <a:stretch/>
        </p:blipFill>
        <p:spPr>
          <a:xfrm>
            <a:off x="5376083" y="3133291"/>
            <a:ext cx="1542134" cy="1540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図 60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" t="62601" r="65235" b="34518"/>
          <a:stretch/>
        </p:blipFill>
        <p:spPr>
          <a:xfrm>
            <a:off x="5393217" y="4809437"/>
            <a:ext cx="1493777" cy="1372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図 61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0" t="57600" r="65321" b="39761"/>
          <a:stretch/>
        </p:blipFill>
        <p:spPr>
          <a:xfrm>
            <a:off x="5406899" y="3960125"/>
            <a:ext cx="1480094" cy="1256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図 62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61000" r="65229" b="35819"/>
          <a:stretch/>
        </p:blipFill>
        <p:spPr>
          <a:xfrm>
            <a:off x="5416424" y="4514161"/>
            <a:ext cx="1475030" cy="1515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図 67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0" t="40400" r="65328" b="56579"/>
          <a:stretch/>
        </p:blipFill>
        <p:spPr>
          <a:xfrm>
            <a:off x="5392613" y="2875862"/>
            <a:ext cx="1498842" cy="1438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図 79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1" t="58201" r="65421" b="39033"/>
          <a:stretch/>
        </p:blipFill>
        <p:spPr>
          <a:xfrm>
            <a:off x="5392612" y="3418786"/>
            <a:ext cx="1494381" cy="1317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1" name="図 80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2" t="46286" r="64945" b="49504"/>
          <a:stretch/>
        </p:blipFill>
        <p:spPr>
          <a:xfrm>
            <a:off x="5383767" y="2043104"/>
            <a:ext cx="1489845" cy="2005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図 81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8" t="39771" r="65257" b="56748"/>
          <a:stretch/>
        </p:blipFill>
        <p:spPr>
          <a:xfrm>
            <a:off x="5377797" y="2309805"/>
            <a:ext cx="1491358" cy="16576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4" name="グループ化 83"/>
          <p:cNvGrpSpPr/>
          <p:nvPr/>
        </p:nvGrpSpPr>
        <p:grpSpPr>
          <a:xfrm>
            <a:off x="9633533" y="1335542"/>
            <a:ext cx="1519773" cy="805645"/>
            <a:chOff x="1174045" y="646726"/>
            <a:chExt cx="1519773" cy="805645"/>
          </a:xfrm>
        </p:grpSpPr>
        <p:sp>
          <p:nvSpPr>
            <p:cNvPr id="85" name="テキスト ボックス 84"/>
            <p:cNvSpPr txBox="1"/>
            <p:nvPr/>
          </p:nvSpPr>
          <p:spPr>
            <a:xfrm>
              <a:off x="1580429" y="646726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I-H1993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1174045" y="1175372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10   100  10   100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>
              <a:off x="1255757" y="938090"/>
              <a:ext cx="811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zo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1933674" y="938090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ectinib</a:t>
              </a:r>
              <a:endParaRPr kumimoji="1"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8" name="直線コネクタ 97"/>
            <p:cNvCxnSpPr/>
            <p:nvPr/>
          </p:nvCxnSpPr>
          <p:spPr>
            <a:xfrm>
              <a:off x="1482290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/>
            <p:cNvCxnSpPr/>
            <p:nvPr/>
          </p:nvCxnSpPr>
          <p:spPr>
            <a:xfrm>
              <a:off x="2058202" y="1196741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4" name="図 113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40482" r="65238" b="56242"/>
          <a:stretch/>
        </p:blipFill>
        <p:spPr>
          <a:xfrm>
            <a:off x="9622709" y="2120238"/>
            <a:ext cx="1476551" cy="156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5" name="図 114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6" t="66258" r="65446" b="31234"/>
          <a:stretch/>
        </p:blipFill>
        <p:spPr>
          <a:xfrm>
            <a:off x="9623935" y="4856205"/>
            <a:ext cx="1460076" cy="119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6" name="図 115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96" t="59438" r="65409" b="37929"/>
          <a:stretch/>
        </p:blipFill>
        <p:spPr>
          <a:xfrm>
            <a:off x="9638627" y="4026492"/>
            <a:ext cx="1461859" cy="1253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7" name="図 116"/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0" t="62689" r="65413" b="34616"/>
          <a:stretch/>
        </p:blipFill>
        <p:spPr>
          <a:xfrm>
            <a:off x="9622709" y="4558981"/>
            <a:ext cx="1457183" cy="1283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8" name="図 117"/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8" t="49735" r="65386" b="47427"/>
          <a:stretch/>
        </p:blipFill>
        <p:spPr>
          <a:xfrm>
            <a:off x="9628219" y="3777817"/>
            <a:ext cx="1480506" cy="1351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9" name="図 118"/>
          <p:cNvPicPr>
            <a:picLocks noChangeAspect="1"/>
          </p:cNvPicPr>
          <p:nvPr/>
        </p:nvPicPr>
        <p:blipFill rotWithShape="1"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53668" r="65327" b="43326"/>
          <a:stretch/>
        </p:blipFill>
        <p:spPr>
          <a:xfrm>
            <a:off x="9628219" y="4296987"/>
            <a:ext cx="1472268" cy="1432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0" name="図 119"/>
          <p:cNvPicPr>
            <a:picLocks noChangeAspect="1"/>
          </p:cNvPicPr>
          <p:nvPr/>
        </p:nvPicPr>
        <p:blipFill rotWithShape="1"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" t="59682" r="65587" b="37894"/>
          <a:stretch/>
        </p:blipFill>
        <p:spPr>
          <a:xfrm>
            <a:off x="9628219" y="3484492"/>
            <a:ext cx="1459912" cy="1275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1" name="図 120"/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2" t="42469" r="65291" b="54533"/>
          <a:stretch/>
        </p:blipFill>
        <p:spPr>
          <a:xfrm>
            <a:off x="9642389" y="2940907"/>
            <a:ext cx="1471462" cy="1427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2" name="図 121"/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0600" r="65255" b="56204"/>
          <a:stretch/>
        </p:blipFill>
        <p:spPr>
          <a:xfrm>
            <a:off x="9630342" y="2639637"/>
            <a:ext cx="1473782" cy="1522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3" name="図 122"/>
          <p:cNvPicPr>
            <a:picLocks noChangeAspect="1"/>
          </p:cNvPicPr>
          <p:nvPr/>
        </p:nvPicPr>
        <p:blipFill rotWithShape="1"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47800" r="65590" b="49484"/>
          <a:stretch/>
        </p:blipFill>
        <p:spPr>
          <a:xfrm>
            <a:off x="9630342" y="3211136"/>
            <a:ext cx="1457788" cy="1293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4" name="図 123"/>
          <p:cNvPicPr>
            <a:picLocks noChangeAspect="1"/>
          </p:cNvPicPr>
          <p:nvPr/>
        </p:nvPicPr>
        <p:blipFill rotWithShape="1"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0" t="40501" r="64947" b="57228"/>
          <a:stretch/>
        </p:blipFill>
        <p:spPr>
          <a:xfrm>
            <a:off x="9649838" y="2397868"/>
            <a:ext cx="1468877" cy="1344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5" name="テキスト ボックス 124"/>
          <p:cNvSpPr txBox="1"/>
          <p:nvPr/>
        </p:nvSpPr>
        <p:spPr>
          <a:xfrm>
            <a:off x="4111536" y="1894165"/>
            <a:ext cx="1283172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T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T 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8351018" y="1977288"/>
            <a:ext cx="1283172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T</a:t>
            </a: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terminus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T C-terminus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TAT3</a:t>
            </a: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KT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KT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  <a:endParaRPr kumimoji="1" lang="en-US" altLang="ja-JP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>
              <a:lnSpc>
                <a:spcPct val="150000"/>
              </a:lnSpc>
            </a:pP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  <a:p>
            <a:pPr algn="r">
              <a:lnSpc>
                <a:spcPct val="150000"/>
              </a:lnSpc>
            </a:pPr>
            <a:r>
              <a:rPr kumimoji="1"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4198607" y="96930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b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8336094" y="1019524"/>
            <a:ext cx="2984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6" t="53030" r="65368" b="43190"/>
          <a:stretch/>
        </p:blipFill>
        <p:spPr>
          <a:xfrm>
            <a:off x="1544236" y="2074174"/>
            <a:ext cx="1471433" cy="18003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71940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70</Words>
  <Application>Microsoft Office PowerPoint</Application>
  <PresentationFormat>ワイド画面</PresentationFormat>
  <Paragraphs>5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54:54Z</dcterms:modified>
</cp:coreProperties>
</file>